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200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3176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1128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7634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8062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055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4841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6866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655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2902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1694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993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4FD35-456A-4200-BE81-E9986D3C1D44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52FF2E-50F4-4364-B926-D7FD106E37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9217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104" y="593494"/>
            <a:ext cx="5305098" cy="4206701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5892" y="809351"/>
            <a:ext cx="5346827" cy="401012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00446" y="691784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7" name="文本框 6"/>
          <p:cNvSpPr txBox="1"/>
          <p:nvPr/>
        </p:nvSpPr>
        <p:spPr>
          <a:xfrm>
            <a:off x="6187453" y="6874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9" name="文本框 8"/>
          <p:cNvSpPr txBox="1"/>
          <p:nvPr/>
        </p:nvSpPr>
        <p:spPr>
          <a:xfrm>
            <a:off x="1452167" y="5415460"/>
            <a:ext cx="93809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GB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structure of the 307 rice accessions.</a:t>
            </a:r>
          </a:p>
          <a:p>
            <a:r>
              <a:rPr lang="en-GB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Neighbour-joining tree of 3K RG. 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en-GB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ircle points on the top of each tree branch represent rice accessions in the GWAS panel of this study. (B) Principal component analysis plots for the first two component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307 accessions</a:t>
            </a:r>
            <a:r>
              <a:rPr lang="en-GB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3472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0</Words>
  <Application>Microsoft Macintosh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邱先进</dc:creator>
  <cp:lastModifiedBy>Microsoft Office 用户</cp:lastModifiedBy>
  <cp:revision>6</cp:revision>
  <dcterms:created xsi:type="dcterms:W3CDTF">2021-09-26T01:02:39Z</dcterms:created>
  <dcterms:modified xsi:type="dcterms:W3CDTF">2022-07-30T12:29:25Z</dcterms:modified>
</cp:coreProperties>
</file>